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9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6171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74917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244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08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4178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5830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0009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29926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0494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2693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76647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8ECEC-DE40-4701-AE29-5E36A6639E95}" type="datetimeFigureOut">
              <a:rPr lang="en-AU" smtClean="0"/>
              <a:t>23/02/202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1A8DB9-C1A8-4217-AA29-71D16FA5FFF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25776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507066" y="44873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5121" name="Picture 6" descr="A group of images of a graph&#10;&#10;AI-generated content may be incorrect.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07066" y="897466"/>
            <a:ext cx="4662824" cy="49318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6194451"/>
            <a:ext cx="10989733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images of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NCap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V16D, MR-40C, PC3, 22Rv1 and DU145 cells treated with DMSO and 5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tra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one or in combination with 5-10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μmol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/L CQ. Images were taken using the </a:t>
            </a:r>
            <a:r>
              <a:rPr kumimoji="0" lang="en-AU" altLang="en-US" sz="1200" b="0" i="1" u="none" strike="noStrike" cap="none" normalizeH="0" baseline="0" dirty="0" err="1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cucyte</a:t>
            </a:r>
            <a:r>
              <a:rPr kumimoji="0" lang="en-AU" altLang="en-US" sz="1200" b="0" i="1" u="none" strike="noStrike" cap="none" normalizeH="0" baseline="0" dirty="0" smtClean="0">
                <a:ln>
                  <a:noFill/>
                </a:ln>
                <a:solidFill>
                  <a:srgbClr val="44546A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x5 system after 5 days of incubation with the drugs.</a:t>
            </a:r>
            <a:endParaRPr kumimoji="0" lang="en-AU" altLang="en-US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9059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SVH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ak Talmor - SVHNS</dc:creator>
  <cp:lastModifiedBy>Barak Talmor - SVHNS</cp:lastModifiedBy>
  <cp:revision>5</cp:revision>
  <dcterms:created xsi:type="dcterms:W3CDTF">2026-02-22T23:33:58Z</dcterms:created>
  <dcterms:modified xsi:type="dcterms:W3CDTF">2026-02-22T23:37:48Z</dcterms:modified>
</cp:coreProperties>
</file>